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-1138" y="-77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F8D04-8E38-45D7-BD60-F7AAE5C207D7}" type="datetimeFigureOut">
              <a:rPr lang="es-ES" smtClean="0"/>
              <a:pPr/>
              <a:t>02/10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EA69-7153-4DB2-AE39-F8F46CB9248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35732" y="1275715"/>
            <a:ext cx="6675437" cy="3876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6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1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897518" y="5365102"/>
            <a:ext cx="8210939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Fig. S1. </a:t>
            </a:r>
            <a:r>
              <a:rPr lang="en-GB" sz="1200" b="1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Twi1 </a:t>
            </a:r>
            <a:r>
              <a:rPr lang="en-GB" sz="12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gene expression in tomato leaves upon water or salicylic acid treatment. 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A quantitative reverse transcription-polymerase chain reaction analysis of </a:t>
            </a:r>
            <a:r>
              <a:rPr lang="en-GB" sz="1200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Twi1 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gene expression in the </a:t>
            </a:r>
            <a:r>
              <a:rPr lang="en-GB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Moneymaker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tomato leaves upon water (H</a:t>
            </a:r>
            <a:r>
              <a:rPr lang="en-GB" sz="1200" baseline="-30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O) or 2 </a:t>
            </a:r>
            <a:r>
              <a:rPr lang="en-GB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mM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salicylic acid (SA) treatment. 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Tomato plants were incubated for 30 minutes, and then transferred to water at time zero (0).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Leaf samples were collected at the indicated time points (0.5, 1, 8 and 24 hours post-treatment). The</a:t>
            </a:r>
            <a:r>
              <a:rPr lang="en-GB" sz="1200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Elongation Factor 1 alpha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gene was used as an endogenous reference. The results correspond to the </a:t>
            </a:r>
            <a:r>
              <a:rPr lang="en-GB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means±SD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of three independent plants from a representative experiment. Experiments were repeated 3 times.</a:t>
            </a:r>
            <a:endParaRPr lang="en-GB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23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24</cp:revision>
  <dcterms:created xsi:type="dcterms:W3CDTF">2018-09-06T08:30:40Z</dcterms:created>
  <dcterms:modified xsi:type="dcterms:W3CDTF">2019-10-02T10:45:51Z</dcterms:modified>
</cp:coreProperties>
</file>